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  <p:sldId id="258" r:id="rId3"/>
    <p:sldId id="259" r:id="rId4"/>
    <p:sldId id="260" r:id="rId5"/>
    <p:sldId id="262" r:id="rId6"/>
    <p:sldId id="261" r:id="rId7"/>
    <p:sldId id="268" r:id="rId8"/>
    <p:sldId id="270" r:id="rId9"/>
    <p:sldId id="271" r:id="rId10"/>
    <p:sldId id="264" r:id="rId11"/>
    <p:sldId id="272" r:id="rId12"/>
    <p:sldId id="265" r:id="rId13"/>
    <p:sldId id="266" r:id="rId14"/>
    <p:sldId id="267" r:id="rId1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5768" autoAdjust="0"/>
    <p:restoredTop sz="94660"/>
  </p:normalViewPr>
  <p:slideViewPr>
    <p:cSldViewPr snapToGrid="0">
      <p:cViewPr varScale="1">
        <p:scale>
          <a:sx n="64" d="100"/>
          <a:sy n="64" d="100"/>
        </p:scale>
        <p:origin x="48" y="6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88106D-E191-4126-A2C7-7CBBB6FDB216}" type="datetimeFigureOut">
              <a:rPr lang="en-US" smtClean="0"/>
              <a:t>8/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B570D9-35EC-4BCE-9FEE-86445CCEC7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26153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88106D-E191-4126-A2C7-7CBBB6FDB216}" type="datetimeFigureOut">
              <a:rPr lang="en-US" smtClean="0"/>
              <a:t>8/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B570D9-35EC-4BCE-9FEE-86445CCEC7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60474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88106D-E191-4126-A2C7-7CBBB6FDB216}" type="datetimeFigureOut">
              <a:rPr lang="en-US" smtClean="0"/>
              <a:t>8/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B570D9-35EC-4BCE-9FEE-86445CCEC7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58297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88106D-E191-4126-A2C7-7CBBB6FDB216}" type="datetimeFigureOut">
              <a:rPr lang="en-US" smtClean="0"/>
              <a:t>8/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B570D9-35EC-4BCE-9FEE-86445CCEC7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61467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88106D-E191-4126-A2C7-7CBBB6FDB216}" type="datetimeFigureOut">
              <a:rPr lang="en-US" smtClean="0"/>
              <a:t>8/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B570D9-35EC-4BCE-9FEE-86445CCEC7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20337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88106D-E191-4126-A2C7-7CBBB6FDB216}" type="datetimeFigureOut">
              <a:rPr lang="en-US" smtClean="0"/>
              <a:t>8/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B570D9-35EC-4BCE-9FEE-86445CCEC7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19533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88106D-E191-4126-A2C7-7CBBB6FDB216}" type="datetimeFigureOut">
              <a:rPr lang="en-US" smtClean="0"/>
              <a:t>8/9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B570D9-35EC-4BCE-9FEE-86445CCEC7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96082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88106D-E191-4126-A2C7-7CBBB6FDB216}" type="datetimeFigureOut">
              <a:rPr lang="en-US" smtClean="0"/>
              <a:t>8/9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B570D9-35EC-4BCE-9FEE-86445CCEC7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44554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88106D-E191-4126-A2C7-7CBBB6FDB216}" type="datetimeFigureOut">
              <a:rPr lang="en-US" smtClean="0"/>
              <a:t>8/9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B570D9-35EC-4BCE-9FEE-86445CCEC7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35649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88106D-E191-4126-A2C7-7CBBB6FDB216}" type="datetimeFigureOut">
              <a:rPr lang="en-US" smtClean="0"/>
              <a:t>8/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B570D9-35EC-4BCE-9FEE-86445CCEC7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08180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88106D-E191-4126-A2C7-7CBBB6FDB216}" type="datetimeFigureOut">
              <a:rPr lang="en-US" smtClean="0"/>
              <a:t>8/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B570D9-35EC-4BCE-9FEE-86445CCEC7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22880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88106D-E191-4126-A2C7-7CBBB6FDB216}" type="datetimeFigureOut">
              <a:rPr lang="en-US" smtClean="0"/>
              <a:t>8/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B570D9-35EC-4BCE-9FEE-86445CCEC7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17905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 10"/>
          <p:cNvGrpSpPr/>
          <p:nvPr/>
        </p:nvGrpSpPr>
        <p:grpSpPr>
          <a:xfrm>
            <a:off x="12700" y="203495"/>
            <a:ext cx="12150900" cy="6813255"/>
            <a:chOff x="12700" y="44745"/>
            <a:chExt cx="12150900" cy="6813255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7576" y="44745"/>
              <a:ext cx="12056024" cy="6813255"/>
            </a:xfrm>
            <a:prstGeom prst="rect">
              <a:avLst/>
            </a:prstGeom>
          </p:spPr>
        </p:pic>
        <p:grpSp>
          <p:nvGrpSpPr>
            <p:cNvPr id="7" name="Group 6"/>
            <p:cNvGrpSpPr/>
            <p:nvPr/>
          </p:nvGrpSpPr>
          <p:grpSpPr>
            <a:xfrm>
              <a:off x="12700" y="2695578"/>
              <a:ext cx="1414460" cy="746358"/>
              <a:chOff x="57150" y="2695578"/>
              <a:chExt cx="1414460" cy="746358"/>
            </a:xfrm>
          </p:grpSpPr>
          <p:sp>
            <p:nvSpPr>
              <p:cNvPr id="6" name="Rectangle 5"/>
              <p:cNvSpPr/>
              <p:nvPr/>
            </p:nvSpPr>
            <p:spPr>
              <a:xfrm>
                <a:off x="57150" y="2767013"/>
                <a:ext cx="1395413" cy="50958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" name="TextBox 4"/>
              <p:cNvSpPr txBox="1"/>
              <p:nvPr/>
            </p:nvSpPr>
            <p:spPr>
              <a:xfrm>
                <a:off x="80960" y="2695578"/>
                <a:ext cx="1390650" cy="74635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50" b="1" i="1" dirty="0" smtClean="0">
                    <a:solidFill>
                      <a:srgbClr val="C0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PLV-YSL1 </a:t>
                </a:r>
                <a:r>
                  <a:rPr lang="en-US" sz="850" b="1" i="1" dirty="0">
                    <a:solidFill>
                      <a:srgbClr val="C0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YSL1</a:t>
                </a:r>
                <a:r>
                  <a:rPr lang="en-US" sz="850" b="1" i="1" dirty="0" smtClean="0">
                    <a:solidFill>
                      <a:srgbClr val="C0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_10</a:t>
                </a:r>
              </a:p>
              <a:p>
                <a:r>
                  <a:rPr lang="en-US" sz="850" b="1" i="1" dirty="0" smtClean="0">
                    <a:solidFill>
                      <a:srgbClr val="C0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PLV-RED2 </a:t>
                </a:r>
                <a:r>
                  <a:rPr lang="en-US" sz="850" b="1" i="1" dirty="0">
                    <a:solidFill>
                      <a:srgbClr val="C0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RED2</a:t>
                </a:r>
                <a:r>
                  <a:rPr lang="en-US" sz="850" b="1" i="1" dirty="0" smtClean="0">
                    <a:solidFill>
                      <a:srgbClr val="C0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_11</a:t>
                </a:r>
              </a:p>
              <a:p>
                <a:r>
                  <a:rPr lang="en-US" sz="850" b="1" i="1" dirty="0" smtClean="0">
                    <a:solidFill>
                      <a:srgbClr val="C0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PLV-SAF1 </a:t>
                </a:r>
                <a:r>
                  <a:rPr lang="en-US" sz="850" b="1" i="1" dirty="0">
                    <a:solidFill>
                      <a:srgbClr val="C0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SAF1</a:t>
                </a:r>
                <a:r>
                  <a:rPr lang="en-US" sz="850" b="1" i="1" dirty="0" smtClean="0">
                    <a:solidFill>
                      <a:srgbClr val="C0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_03</a:t>
                </a:r>
              </a:p>
              <a:p>
                <a:r>
                  <a:rPr lang="en-US" sz="850" b="1" i="1" dirty="0" smtClean="0">
                    <a:solidFill>
                      <a:srgbClr val="C0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PLV-RED1 RED1_13</a:t>
                </a:r>
                <a:endParaRPr lang="en-US" sz="850" b="1" i="1" dirty="0">
                  <a:solidFill>
                    <a:srgbClr val="C0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  <a:p>
                <a:endParaRPr lang="en-US" sz="850" b="1" i="1" dirty="0">
                  <a:solidFill>
                    <a:srgbClr val="C0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</p:txBody>
          </p:sp>
        </p:grpSp>
        <p:grpSp>
          <p:nvGrpSpPr>
            <p:cNvPr id="8" name="Group 7"/>
            <p:cNvGrpSpPr/>
            <p:nvPr/>
          </p:nvGrpSpPr>
          <p:grpSpPr>
            <a:xfrm>
              <a:off x="19050" y="6080128"/>
              <a:ext cx="1414460" cy="746358"/>
              <a:chOff x="57150" y="2695578"/>
              <a:chExt cx="1414460" cy="746358"/>
            </a:xfrm>
          </p:grpSpPr>
          <p:sp>
            <p:nvSpPr>
              <p:cNvPr id="9" name="Rectangle 8"/>
              <p:cNvSpPr/>
              <p:nvPr/>
            </p:nvSpPr>
            <p:spPr>
              <a:xfrm>
                <a:off x="57150" y="2767013"/>
                <a:ext cx="1395413" cy="50958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80960" y="2695578"/>
                <a:ext cx="1390650" cy="74635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50" b="1" i="1" dirty="0" smtClean="0">
                    <a:solidFill>
                      <a:srgbClr val="C0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PLV-YSL1 </a:t>
                </a:r>
                <a:r>
                  <a:rPr lang="en-US" sz="850" b="1" i="1" dirty="0">
                    <a:solidFill>
                      <a:srgbClr val="C0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YSL1</a:t>
                </a:r>
                <a:r>
                  <a:rPr lang="en-US" sz="850" b="1" i="1" dirty="0" smtClean="0">
                    <a:solidFill>
                      <a:srgbClr val="C0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_10</a:t>
                </a:r>
              </a:p>
              <a:p>
                <a:r>
                  <a:rPr lang="en-US" sz="850" b="1" i="1" dirty="0" smtClean="0">
                    <a:solidFill>
                      <a:srgbClr val="C0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PLV-RED2 </a:t>
                </a:r>
                <a:r>
                  <a:rPr lang="en-US" sz="850" b="1" i="1" dirty="0">
                    <a:solidFill>
                      <a:srgbClr val="C0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RED2</a:t>
                </a:r>
                <a:r>
                  <a:rPr lang="en-US" sz="850" b="1" i="1" dirty="0" smtClean="0">
                    <a:solidFill>
                      <a:srgbClr val="C0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_11</a:t>
                </a:r>
              </a:p>
              <a:p>
                <a:r>
                  <a:rPr lang="en-US" sz="850" b="1" i="1" dirty="0" smtClean="0">
                    <a:solidFill>
                      <a:srgbClr val="C0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PLV-SAF1 </a:t>
                </a:r>
                <a:r>
                  <a:rPr lang="en-US" sz="850" b="1" i="1" dirty="0">
                    <a:solidFill>
                      <a:srgbClr val="C0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SAF1</a:t>
                </a:r>
                <a:r>
                  <a:rPr lang="en-US" sz="850" b="1" i="1" dirty="0" smtClean="0">
                    <a:solidFill>
                      <a:srgbClr val="C0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_03</a:t>
                </a:r>
              </a:p>
              <a:p>
                <a:r>
                  <a:rPr lang="en-US" sz="850" b="1" i="1" dirty="0" smtClean="0">
                    <a:solidFill>
                      <a:srgbClr val="C0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PLV-RED1 RED1_13</a:t>
                </a:r>
                <a:endParaRPr lang="en-US" sz="850" b="1" i="1" dirty="0">
                  <a:solidFill>
                    <a:srgbClr val="C0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  <a:p>
                <a:endParaRPr lang="en-US" sz="850" b="1" i="1" dirty="0">
                  <a:solidFill>
                    <a:srgbClr val="C0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</p:txBody>
          </p:sp>
        </p:grpSp>
      </p:grpSp>
      <p:sp>
        <p:nvSpPr>
          <p:cNvPr id="12" name="TextBox 11"/>
          <p:cNvSpPr txBox="1"/>
          <p:nvPr/>
        </p:nvSpPr>
        <p:spPr>
          <a:xfrm>
            <a:off x="304800" y="0"/>
            <a:ext cx="18097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 smtClean="0"/>
              <a:t>Yrec</a:t>
            </a:r>
            <a:r>
              <a:rPr lang="en-US" dirty="0" smtClean="0"/>
              <a:t> (OLV11)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320514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04800" y="0"/>
            <a:ext cx="18097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TPase</a:t>
            </a:r>
            <a:endParaRPr lang="en-US" dirty="0"/>
          </a:p>
        </p:txBody>
      </p:sp>
      <p:sp>
        <p:nvSpPr>
          <p:cNvPr id="6" name="Rectangle 5"/>
          <p:cNvSpPr/>
          <p:nvPr/>
        </p:nvSpPr>
        <p:spPr>
          <a:xfrm>
            <a:off x="1098886" y="3284622"/>
            <a:ext cx="11470105" cy="28073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t="2854" b="2956"/>
          <a:stretch/>
        </p:blipFill>
        <p:spPr>
          <a:xfrm>
            <a:off x="450580" y="352270"/>
            <a:ext cx="11681460" cy="64307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364429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04800" y="0"/>
            <a:ext cx="18097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TPase (</a:t>
            </a:r>
            <a:r>
              <a:rPr lang="en-US" dirty="0" err="1" smtClean="0"/>
              <a:t>cont</a:t>
            </a:r>
            <a:r>
              <a:rPr lang="en-US" dirty="0" smtClean="0"/>
              <a:t>)</a:t>
            </a:r>
            <a:endParaRPr lang="en-US" dirty="0"/>
          </a:p>
        </p:txBody>
      </p:sp>
      <p:sp>
        <p:nvSpPr>
          <p:cNvPr id="6" name="Rectangle 5"/>
          <p:cNvSpPr/>
          <p:nvPr/>
        </p:nvSpPr>
        <p:spPr>
          <a:xfrm>
            <a:off x="1098886" y="3284622"/>
            <a:ext cx="11470105" cy="28073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/>
          <a:srcRect t="3056" b="2864"/>
          <a:stretch/>
        </p:blipFill>
        <p:spPr>
          <a:xfrm>
            <a:off x="345648" y="352268"/>
            <a:ext cx="11681460" cy="64232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595943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04800" y="0"/>
            <a:ext cx="18097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Tlr6F</a:t>
            </a:r>
            <a:endParaRPr lang="en-US" dirty="0"/>
          </a:p>
        </p:txBody>
      </p:sp>
      <p:sp>
        <p:nvSpPr>
          <p:cNvPr id="6" name="Rectangle 5"/>
          <p:cNvSpPr/>
          <p:nvPr/>
        </p:nvSpPr>
        <p:spPr>
          <a:xfrm>
            <a:off x="1098886" y="3284622"/>
            <a:ext cx="11470105" cy="28073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t="5834" b="1658"/>
          <a:stretch/>
        </p:blipFill>
        <p:spPr>
          <a:xfrm>
            <a:off x="149901" y="2473378"/>
            <a:ext cx="11850017" cy="33278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064003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289810" y="359764"/>
            <a:ext cx="18097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GIY</a:t>
            </a:r>
            <a:endParaRPr lang="en-US" dirty="0"/>
          </a:p>
        </p:txBody>
      </p:sp>
      <p:sp>
        <p:nvSpPr>
          <p:cNvPr id="6" name="Rectangle 5"/>
          <p:cNvSpPr/>
          <p:nvPr/>
        </p:nvSpPr>
        <p:spPr>
          <a:xfrm>
            <a:off x="1098886" y="3284622"/>
            <a:ext cx="11470105" cy="28073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t="4818" b="2081"/>
          <a:stretch/>
        </p:blipFill>
        <p:spPr>
          <a:xfrm>
            <a:off x="134911" y="1289155"/>
            <a:ext cx="11925538" cy="42871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043584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0" y="0"/>
            <a:ext cx="12568991" cy="6903028"/>
            <a:chOff x="0" y="0"/>
            <a:chExt cx="12568991" cy="6903028"/>
          </a:xfrm>
        </p:grpSpPr>
        <p:sp>
          <p:nvSpPr>
            <p:cNvPr id="5" name="TextBox 4"/>
            <p:cNvSpPr txBox="1"/>
            <p:nvPr/>
          </p:nvSpPr>
          <p:spPr>
            <a:xfrm>
              <a:off x="0" y="0"/>
              <a:ext cx="180975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Lipase</a:t>
              </a:r>
              <a:endParaRPr lang="en-US" dirty="0"/>
            </a:p>
          </p:txBody>
        </p:sp>
        <p:sp>
          <p:nvSpPr>
            <p:cNvPr id="6" name="Rectangle 5"/>
            <p:cNvSpPr/>
            <p:nvPr/>
          </p:nvSpPr>
          <p:spPr>
            <a:xfrm>
              <a:off x="1098886" y="3284622"/>
              <a:ext cx="11470105" cy="28073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t="2690"/>
            <a:stretch/>
          </p:blipFill>
          <p:spPr>
            <a:xfrm>
              <a:off x="914400" y="60158"/>
              <a:ext cx="11150766" cy="6842870"/>
            </a:xfrm>
            <a:prstGeom prst="rect">
              <a:avLst/>
            </a:prstGeom>
          </p:spPr>
        </p:pic>
        <p:sp>
          <p:nvSpPr>
            <p:cNvPr id="7" name="Rectangle 6"/>
            <p:cNvSpPr/>
            <p:nvPr/>
          </p:nvSpPr>
          <p:spPr>
            <a:xfrm>
              <a:off x="721895" y="3279859"/>
              <a:ext cx="11470105" cy="30555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10909918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oup 13"/>
          <p:cNvGrpSpPr/>
          <p:nvPr/>
        </p:nvGrpSpPr>
        <p:grpSpPr>
          <a:xfrm>
            <a:off x="304800" y="-156411"/>
            <a:ext cx="12252160" cy="7180848"/>
            <a:chOff x="304800" y="-156411"/>
            <a:chExt cx="12252160" cy="7180848"/>
          </a:xfrm>
        </p:grpSpPr>
        <p:grpSp>
          <p:nvGrpSpPr>
            <p:cNvPr id="12" name="Group 11"/>
            <p:cNvGrpSpPr/>
            <p:nvPr/>
          </p:nvGrpSpPr>
          <p:grpSpPr>
            <a:xfrm>
              <a:off x="304800" y="-156411"/>
              <a:ext cx="12252160" cy="7014411"/>
              <a:chOff x="304800" y="-156411"/>
              <a:chExt cx="12252160" cy="7014411"/>
            </a:xfrm>
          </p:grpSpPr>
          <p:sp>
            <p:nvSpPr>
              <p:cNvPr id="5" name="TextBox 4"/>
              <p:cNvSpPr txBox="1"/>
              <p:nvPr/>
            </p:nvSpPr>
            <p:spPr>
              <a:xfrm>
                <a:off x="304800" y="0"/>
                <a:ext cx="180975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err="1" smtClean="0"/>
                  <a:t>PolB</a:t>
                </a:r>
                <a:endParaRPr lang="en-US" dirty="0"/>
              </a:p>
            </p:txBody>
          </p:sp>
          <p:pic>
            <p:nvPicPr>
              <p:cNvPr id="7" name="Picture 6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050758" y="-29314"/>
                <a:ext cx="11141242" cy="6887314"/>
              </a:xfrm>
              <a:prstGeom prst="rect">
                <a:avLst/>
              </a:prstGeom>
            </p:spPr>
          </p:pic>
          <p:sp>
            <p:nvSpPr>
              <p:cNvPr id="8" name="Rectangle 7"/>
              <p:cNvSpPr/>
              <p:nvPr/>
            </p:nvSpPr>
            <p:spPr>
              <a:xfrm>
                <a:off x="842214" y="-156411"/>
                <a:ext cx="11470105" cy="33688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" name="Rectangle 8"/>
              <p:cNvSpPr/>
              <p:nvPr/>
            </p:nvSpPr>
            <p:spPr>
              <a:xfrm>
                <a:off x="910392" y="1612231"/>
                <a:ext cx="11470105" cy="260683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" name="Rectangle 9"/>
              <p:cNvSpPr/>
              <p:nvPr/>
            </p:nvSpPr>
            <p:spPr>
              <a:xfrm>
                <a:off x="858255" y="3352799"/>
                <a:ext cx="11470105" cy="260683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1" name="Rectangle 10"/>
              <p:cNvSpPr/>
              <p:nvPr/>
            </p:nvSpPr>
            <p:spPr>
              <a:xfrm>
                <a:off x="1086855" y="5061285"/>
                <a:ext cx="11470105" cy="260683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13" name="Rectangle 12"/>
            <p:cNvSpPr/>
            <p:nvPr/>
          </p:nvSpPr>
          <p:spPr>
            <a:xfrm>
              <a:off x="962528" y="6763754"/>
              <a:ext cx="11470105" cy="26068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322778413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2663" y="149693"/>
            <a:ext cx="11853111" cy="6804563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304800" y="0"/>
            <a:ext cx="18097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3H helicas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220649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04800" y="0"/>
            <a:ext cx="18097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 smtClean="0"/>
              <a:t>Tlr</a:t>
            </a:r>
            <a:r>
              <a:rPr lang="en-US" dirty="0" smtClean="0"/>
              <a:t> helicase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/>
          <a:srcRect t="2690" b="1247"/>
          <a:stretch/>
        </p:blipFill>
        <p:spPr>
          <a:xfrm>
            <a:off x="1804233" y="0"/>
            <a:ext cx="10179218" cy="6819900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1098886" y="3284622"/>
            <a:ext cx="11470105" cy="28073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03306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04800" y="0"/>
            <a:ext cx="180975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 smtClean="0"/>
              <a:t>Tlr</a:t>
            </a:r>
            <a:r>
              <a:rPr lang="en-US" dirty="0" smtClean="0"/>
              <a:t> helicase (cont.)</a:t>
            </a:r>
            <a:endParaRPr lang="en-US" dirty="0"/>
          </a:p>
        </p:txBody>
      </p:sp>
      <p:sp>
        <p:nvSpPr>
          <p:cNvPr id="6" name="Rectangle 5"/>
          <p:cNvSpPr/>
          <p:nvPr/>
        </p:nvSpPr>
        <p:spPr>
          <a:xfrm>
            <a:off x="1098886" y="3284622"/>
            <a:ext cx="11470105" cy="28073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t="5355" b="2755"/>
          <a:stretch/>
        </p:blipFill>
        <p:spPr>
          <a:xfrm>
            <a:off x="733927" y="1095375"/>
            <a:ext cx="11337757" cy="36330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452542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 9"/>
          <p:cNvGrpSpPr/>
          <p:nvPr/>
        </p:nvGrpSpPr>
        <p:grpSpPr>
          <a:xfrm>
            <a:off x="304800" y="0"/>
            <a:ext cx="12252160" cy="6959273"/>
            <a:chOff x="304800" y="0"/>
            <a:chExt cx="12252160" cy="6959273"/>
          </a:xfrm>
        </p:grpSpPr>
        <p:sp>
          <p:nvSpPr>
            <p:cNvPr id="5" name="TextBox 4"/>
            <p:cNvSpPr txBox="1"/>
            <p:nvPr/>
          </p:nvSpPr>
          <p:spPr>
            <a:xfrm>
              <a:off x="304800" y="0"/>
              <a:ext cx="180975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err="1" smtClean="0"/>
                <a:t>mCP</a:t>
              </a:r>
              <a:endParaRPr lang="en-US" dirty="0"/>
            </a:p>
          </p:txBody>
        </p:sp>
        <p:pic>
          <p:nvPicPr>
            <p:cNvPr id="3" name="Picture 2"/>
            <p:cNvPicPr>
              <a:picLocks noChangeAspect="1" noChangeArrowheads="1"/>
            </p:cNvPicPr>
            <p:nvPr/>
          </p:nvPicPr>
          <p:blipFill rotWithShape="1">
            <a:blip r:embed="rId2" cstate="print"/>
            <a:srcRect t="3208" b="1581"/>
            <a:stretch/>
          </p:blipFill>
          <p:spPr bwMode="auto">
            <a:xfrm>
              <a:off x="1600200" y="48128"/>
              <a:ext cx="9002078" cy="442761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4" name="Picture 3"/>
            <p:cNvPicPr>
              <a:picLocks noChangeAspect="1" noChangeArrowheads="1"/>
            </p:cNvPicPr>
            <p:nvPr/>
          </p:nvPicPr>
          <p:blipFill rotWithShape="1">
            <a:blip r:embed="rId3" cstate="print"/>
            <a:srcRect t="7268"/>
            <a:stretch/>
          </p:blipFill>
          <p:spPr bwMode="auto">
            <a:xfrm>
              <a:off x="1600199" y="4681106"/>
              <a:ext cx="9289569" cy="22250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6" name="Rectangle 5"/>
            <p:cNvSpPr/>
            <p:nvPr/>
          </p:nvSpPr>
          <p:spPr>
            <a:xfrm>
              <a:off x="1086855" y="2160922"/>
              <a:ext cx="11470105" cy="2286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Rectangle 6"/>
            <p:cNvSpPr/>
            <p:nvPr/>
          </p:nvSpPr>
          <p:spPr>
            <a:xfrm rot="5400000">
              <a:off x="-1673139" y="3167311"/>
              <a:ext cx="6858000" cy="52337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" name="Rectangle 1"/>
            <p:cNvSpPr/>
            <p:nvPr/>
          </p:nvSpPr>
          <p:spPr>
            <a:xfrm>
              <a:off x="1626775" y="18238"/>
              <a:ext cx="6096000" cy="2197525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r>
                <a:rPr lang="en-US" sz="570" dirty="0"/>
                <a:t>PLV-YSL5</a:t>
              </a:r>
            </a:p>
            <a:p>
              <a:r>
                <a:rPr lang="en-US" sz="570" dirty="0"/>
                <a:t>PLV-SPO1</a:t>
              </a:r>
            </a:p>
            <a:p>
              <a:r>
                <a:rPr lang="en-US" sz="570" dirty="0" err="1"/>
                <a:t>Tlr</a:t>
              </a:r>
              <a:r>
                <a:rPr lang="en-US" sz="570" dirty="0"/>
                <a:t>	</a:t>
              </a:r>
            </a:p>
            <a:p>
              <a:r>
                <a:rPr lang="en-US" sz="570" dirty="0"/>
                <a:t>PLV-SAF2</a:t>
              </a:r>
            </a:p>
            <a:p>
              <a:r>
                <a:rPr lang="en-US" sz="570" dirty="0"/>
                <a:t>PLV-MED1</a:t>
              </a:r>
            </a:p>
            <a:p>
              <a:r>
                <a:rPr lang="en-US" sz="570" dirty="0"/>
                <a:t>PLV-SAF3</a:t>
              </a:r>
            </a:p>
            <a:p>
              <a:r>
                <a:rPr lang="en-US" sz="570" dirty="0"/>
                <a:t>PLV-RED1</a:t>
              </a:r>
            </a:p>
            <a:p>
              <a:r>
                <a:rPr lang="en-US" sz="570" dirty="0"/>
                <a:t>PLV-SAF1</a:t>
              </a:r>
            </a:p>
            <a:p>
              <a:r>
                <a:rPr lang="en-US" sz="570" dirty="0"/>
                <a:t>PLV-YSL3</a:t>
              </a:r>
            </a:p>
            <a:p>
              <a:r>
                <a:rPr lang="en-US" sz="570" dirty="0"/>
                <a:t>PLV-YSL1</a:t>
              </a:r>
            </a:p>
            <a:p>
              <a:r>
                <a:rPr lang="en-US" sz="570" dirty="0"/>
                <a:t>PLV-YSL6</a:t>
              </a:r>
            </a:p>
            <a:p>
              <a:r>
                <a:rPr lang="en-US" sz="570" dirty="0"/>
                <a:t>PLV-ACE1</a:t>
              </a:r>
            </a:p>
            <a:p>
              <a:r>
                <a:rPr lang="en-US" sz="570" dirty="0"/>
                <a:t>F_Guil2	</a:t>
              </a:r>
            </a:p>
            <a:p>
              <a:r>
                <a:rPr lang="en-US" sz="570" dirty="0"/>
                <a:t>PLV-SAF4</a:t>
              </a:r>
            </a:p>
            <a:p>
              <a:r>
                <a:rPr lang="en-US" sz="570" dirty="0"/>
                <a:t>PGVV	</a:t>
              </a:r>
            </a:p>
            <a:p>
              <a:r>
                <a:rPr lang="en-US" sz="570" dirty="0"/>
                <a:t>PLV-YSL4</a:t>
              </a:r>
            </a:p>
            <a:p>
              <a:r>
                <a:rPr lang="en-US" sz="570" dirty="0"/>
                <a:t>PLV-RED2</a:t>
              </a:r>
            </a:p>
            <a:p>
              <a:r>
                <a:rPr lang="en-US" sz="570" dirty="0"/>
                <a:t>F_Guil3	</a:t>
              </a:r>
            </a:p>
            <a:p>
              <a:r>
                <a:rPr lang="en-US" sz="570" dirty="0" err="1"/>
                <a:t>Mneg</a:t>
              </a:r>
              <a:r>
                <a:rPr lang="en-US" sz="570" dirty="0"/>
                <a:t>	</a:t>
              </a:r>
            </a:p>
            <a:p>
              <a:r>
                <a:rPr lang="en-US" sz="570" dirty="0"/>
                <a:t>PLV-SPO2</a:t>
              </a:r>
            </a:p>
            <a:p>
              <a:r>
                <a:rPr lang="en-US" sz="570" dirty="0"/>
                <a:t>PLV-SAF5</a:t>
              </a:r>
            </a:p>
            <a:p>
              <a:r>
                <a:rPr lang="en-US" sz="570" dirty="0"/>
                <a:t>PLV-SAF6</a:t>
              </a:r>
            </a:p>
            <a:p>
              <a:r>
                <a:rPr lang="en-US" sz="570" dirty="0"/>
                <a:t>F_Guil1	</a:t>
              </a:r>
            </a:p>
            <a:p>
              <a:r>
                <a:rPr lang="en-US" sz="570" dirty="0"/>
                <a:t>PLV-YSL2</a:t>
              </a:r>
            </a:p>
          </p:txBody>
        </p:sp>
        <p:sp>
          <p:nvSpPr>
            <p:cNvPr id="8" name="Rectangle 7"/>
            <p:cNvSpPr/>
            <p:nvPr/>
          </p:nvSpPr>
          <p:spPr>
            <a:xfrm>
              <a:off x="1626775" y="2343343"/>
              <a:ext cx="6096000" cy="2197525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r>
                <a:rPr lang="en-US" sz="570" dirty="0"/>
                <a:t>PLV-YSL5</a:t>
              </a:r>
            </a:p>
            <a:p>
              <a:r>
                <a:rPr lang="en-US" sz="570" dirty="0"/>
                <a:t>PLV-SPO1</a:t>
              </a:r>
            </a:p>
            <a:p>
              <a:r>
                <a:rPr lang="en-US" sz="570" dirty="0" err="1"/>
                <a:t>Tlr</a:t>
              </a:r>
              <a:r>
                <a:rPr lang="en-US" sz="570" dirty="0"/>
                <a:t>	</a:t>
              </a:r>
            </a:p>
            <a:p>
              <a:r>
                <a:rPr lang="en-US" sz="570" dirty="0"/>
                <a:t>PLV-SAF2</a:t>
              </a:r>
            </a:p>
            <a:p>
              <a:r>
                <a:rPr lang="en-US" sz="570" dirty="0"/>
                <a:t>PLV-MED1</a:t>
              </a:r>
            </a:p>
            <a:p>
              <a:r>
                <a:rPr lang="en-US" sz="570" dirty="0"/>
                <a:t>PLV-SAF3</a:t>
              </a:r>
            </a:p>
            <a:p>
              <a:r>
                <a:rPr lang="en-US" sz="570" dirty="0"/>
                <a:t>PLV-RED1</a:t>
              </a:r>
            </a:p>
            <a:p>
              <a:r>
                <a:rPr lang="en-US" sz="570" dirty="0"/>
                <a:t>PLV-SAF1</a:t>
              </a:r>
            </a:p>
            <a:p>
              <a:r>
                <a:rPr lang="en-US" sz="570" dirty="0"/>
                <a:t>PLV-YSL3</a:t>
              </a:r>
            </a:p>
            <a:p>
              <a:r>
                <a:rPr lang="en-US" sz="570" dirty="0"/>
                <a:t>PLV-YSL1</a:t>
              </a:r>
            </a:p>
            <a:p>
              <a:r>
                <a:rPr lang="en-US" sz="570" dirty="0"/>
                <a:t>PLV-YSL6</a:t>
              </a:r>
            </a:p>
            <a:p>
              <a:r>
                <a:rPr lang="en-US" sz="570" dirty="0"/>
                <a:t>PLV-ACE1</a:t>
              </a:r>
            </a:p>
            <a:p>
              <a:r>
                <a:rPr lang="en-US" sz="570" dirty="0"/>
                <a:t>F_Guil2	</a:t>
              </a:r>
            </a:p>
            <a:p>
              <a:r>
                <a:rPr lang="en-US" sz="570" dirty="0"/>
                <a:t>PLV-SAF4</a:t>
              </a:r>
            </a:p>
            <a:p>
              <a:r>
                <a:rPr lang="en-US" sz="570" dirty="0"/>
                <a:t>PGVV	</a:t>
              </a:r>
            </a:p>
            <a:p>
              <a:r>
                <a:rPr lang="en-US" sz="570" dirty="0"/>
                <a:t>PLV-YSL4</a:t>
              </a:r>
            </a:p>
            <a:p>
              <a:r>
                <a:rPr lang="en-US" sz="570" dirty="0"/>
                <a:t>PLV-RED2</a:t>
              </a:r>
            </a:p>
            <a:p>
              <a:r>
                <a:rPr lang="en-US" sz="570" dirty="0"/>
                <a:t>F_Guil3	</a:t>
              </a:r>
            </a:p>
            <a:p>
              <a:r>
                <a:rPr lang="en-US" sz="570" dirty="0" err="1"/>
                <a:t>Mneg</a:t>
              </a:r>
              <a:r>
                <a:rPr lang="en-US" sz="570" dirty="0"/>
                <a:t>	</a:t>
              </a:r>
            </a:p>
            <a:p>
              <a:r>
                <a:rPr lang="en-US" sz="570" dirty="0"/>
                <a:t>PLV-SPO2</a:t>
              </a:r>
            </a:p>
            <a:p>
              <a:r>
                <a:rPr lang="en-US" sz="570" dirty="0"/>
                <a:t>PLV-SAF5</a:t>
              </a:r>
            </a:p>
            <a:p>
              <a:r>
                <a:rPr lang="en-US" sz="570" dirty="0"/>
                <a:t>PLV-SAF6</a:t>
              </a:r>
            </a:p>
            <a:p>
              <a:r>
                <a:rPr lang="en-US" sz="570" dirty="0"/>
                <a:t>F_Guil1	</a:t>
              </a:r>
            </a:p>
            <a:p>
              <a:r>
                <a:rPr lang="en-US" sz="570" dirty="0"/>
                <a:t>PLV-YSL2</a:t>
              </a:r>
            </a:p>
          </p:txBody>
        </p:sp>
        <p:sp>
          <p:nvSpPr>
            <p:cNvPr id="9" name="Rectangle 8"/>
            <p:cNvSpPr/>
            <p:nvPr/>
          </p:nvSpPr>
          <p:spPr>
            <a:xfrm>
              <a:off x="1626775" y="4650949"/>
              <a:ext cx="6096000" cy="2308324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r>
                <a:rPr lang="en-US" sz="580" dirty="0"/>
                <a:t>PLV-YSL5</a:t>
              </a:r>
            </a:p>
            <a:p>
              <a:r>
                <a:rPr lang="en-US" sz="580" dirty="0"/>
                <a:t>PLV-SPO1</a:t>
              </a:r>
            </a:p>
            <a:p>
              <a:r>
                <a:rPr lang="en-US" sz="580" dirty="0" err="1"/>
                <a:t>Tlr</a:t>
              </a:r>
              <a:r>
                <a:rPr lang="en-US" sz="580" dirty="0"/>
                <a:t>	</a:t>
              </a:r>
            </a:p>
            <a:p>
              <a:r>
                <a:rPr lang="en-US" sz="580" dirty="0"/>
                <a:t>PLV-SAF2</a:t>
              </a:r>
            </a:p>
            <a:p>
              <a:r>
                <a:rPr lang="en-US" sz="580" dirty="0"/>
                <a:t>PLV-MED1</a:t>
              </a:r>
            </a:p>
            <a:p>
              <a:r>
                <a:rPr lang="en-US" sz="580" dirty="0"/>
                <a:t>PLV-SAF3</a:t>
              </a:r>
            </a:p>
            <a:p>
              <a:r>
                <a:rPr lang="en-US" sz="580" dirty="0"/>
                <a:t>PLV-RED1</a:t>
              </a:r>
            </a:p>
            <a:p>
              <a:r>
                <a:rPr lang="en-US" sz="580" dirty="0"/>
                <a:t>PLV-SAF1</a:t>
              </a:r>
            </a:p>
            <a:p>
              <a:r>
                <a:rPr lang="en-US" sz="580" dirty="0"/>
                <a:t>PLV-YSL3</a:t>
              </a:r>
            </a:p>
            <a:p>
              <a:r>
                <a:rPr lang="en-US" sz="580" dirty="0"/>
                <a:t>PLV-YSL1</a:t>
              </a:r>
            </a:p>
            <a:p>
              <a:r>
                <a:rPr lang="en-US" sz="580" dirty="0"/>
                <a:t>PLV-YSL6</a:t>
              </a:r>
            </a:p>
            <a:p>
              <a:r>
                <a:rPr lang="en-US" sz="580" dirty="0"/>
                <a:t>PLV-ACE1</a:t>
              </a:r>
            </a:p>
            <a:p>
              <a:r>
                <a:rPr lang="en-US" sz="580" dirty="0"/>
                <a:t>F_Guil2	</a:t>
              </a:r>
            </a:p>
            <a:p>
              <a:r>
                <a:rPr lang="en-US" sz="580" dirty="0"/>
                <a:t>PLV-SAF4</a:t>
              </a:r>
            </a:p>
            <a:p>
              <a:r>
                <a:rPr lang="en-US" sz="580" dirty="0"/>
                <a:t>PGVV	</a:t>
              </a:r>
            </a:p>
            <a:p>
              <a:r>
                <a:rPr lang="en-US" sz="580" dirty="0"/>
                <a:t>PLV-YSL4</a:t>
              </a:r>
            </a:p>
            <a:p>
              <a:r>
                <a:rPr lang="en-US" sz="580" dirty="0"/>
                <a:t>PLV-RED2</a:t>
              </a:r>
            </a:p>
            <a:p>
              <a:r>
                <a:rPr lang="en-US" sz="580" dirty="0"/>
                <a:t>F_Guil3	</a:t>
              </a:r>
            </a:p>
            <a:p>
              <a:r>
                <a:rPr lang="en-US" sz="580" dirty="0" err="1"/>
                <a:t>Mneg</a:t>
              </a:r>
              <a:r>
                <a:rPr lang="en-US" sz="580" dirty="0"/>
                <a:t>	</a:t>
              </a:r>
            </a:p>
            <a:p>
              <a:r>
                <a:rPr lang="en-US" sz="580" dirty="0"/>
                <a:t>PLV-SPO2</a:t>
              </a:r>
            </a:p>
            <a:p>
              <a:r>
                <a:rPr lang="en-US" sz="580" dirty="0"/>
                <a:t>PLV-SAF5</a:t>
              </a:r>
            </a:p>
            <a:p>
              <a:r>
                <a:rPr lang="en-US" sz="580" dirty="0"/>
                <a:t>PLV-SAF6</a:t>
              </a:r>
            </a:p>
            <a:p>
              <a:r>
                <a:rPr lang="en-US" sz="580" dirty="0"/>
                <a:t>F_Guil1	</a:t>
              </a:r>
            </a:p>
            <a:p>
              <a:r>
                <a:rPr lang="en-US" sz="580" dirty="0"/>
                <a:t>PLV-YSL2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23309121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04800" y="0"/>
            <a:ext cx="18097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MCP </a:t>
            </a:r>
            <a:endParaRPr lang="en-US" dirty="0"/>
          </a:p>
        </p:txBody>
      </p:sp>
      <p:sp>
        <p:nvSpPr>
          <p:cNvPr id="6" name="Rectangle 5"/>
          <p:cNvSpPr/>
          <p:nvPr/>
        </p:nvSpPr>
        <p:spPr>
          <a:xfrm>
            <a:off x="1098886" y="3284622"/>
            <a:ext cx="11470105" cy="28073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t="4077" b="1905"/>
          <a:stretch/>
        </p:blipFill>
        <p:spPr>
          <a:xfrm>
            <a:off x="75521" y="944380"/>
            <a:ext cx="12071509" cy="46889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375369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04800" y="0"/>
            <a:ext cx="18097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MCP (cont.)</a:t>
            </a:r>
            <a:endParaRPr lang="en-US" dirty="0"/>
          </a:p>
        </p:txBody>
      </p:sp>
      <p:sp>
        <p:nvSpPr>
          <p:cNvPr id="6" name="Rectangle 5"/>
          <p:cNvSpPr/>
          <p:nvPr/>
        </p:nvSpPr>
        <p:spPr>
          <a:xfrm>
            <a:off x="1098886" y="3284622"/>
            <a:ext cx="11470105" cy="28073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9" name="Group 8"/>
          <p:cNvGrpSpPr/>
          <p:nvPr/>
        </p:nvGrpSpPr>
        <p:grpSpPr>
          <a:xfrm>
            <a:off x="-7239992" y="703484"/>
            <a:ext cx="18779574" cy="4698487"/>
            <a:chOff x="-7779632" y="703484"/>
            <a:chExt cx="18779574" cy="4698487"/>
          </a:xfrm>
        </p:grpSpPr>
        <p:grpSp>
          <p:nvGrpSpPr>
            <p:cNvPr id="4" name="Group 3"/>
            <p:cNvGrpSpPr/>
            <p:nvPr/>
          </p:nvGrpSpPr>
          <p:grpSpPr>
            <a:xfrm>
              <a:off x="-7779632" y="714562"/>
              <a:ext cx="12401293" cy="4687409"/>
              <a:chOff x="-3444670" y="1624002"/>
              <a:chExt cx="12401293" cy="4687409"/>
            </a:xfrm>
          </p:grpSpPr>
          <p:pic>
            <p:nvPicPr>
              <p:cNvPr id="3" name="Picture 2"/>
              <p:cNvPicPr>
                <a:picLocks noChangeAspect="1"/>
              </p:cNvPicPr>
              <p:nvPr/>
            </p:nvPicPr>
            <p:blipFill rotWithShape="1">
              <a:blip r:embed="rId2"/>
              <a:srcRect l="97568" t="4490" b="1905"/>
              <a:stretch/>
            </p:blipFill>
            <p:spPr>
              <a:xfrm>
                <a:off x="8662988" y="1624002"/>
                <a:ext cx="293635" cy="4668348"/>
              </a:xfrm>
              <a:prstGeom prst="rect">
                <a:avLst/>
              </a:prstGeom>
            </p:spPr>
          </p:pic>
          <p:pic>
            <p:nvPicPr>
              <p:cNvPr id="7" name="Picture 6"/>
              <p:cNvPicPr>
                <a:picLocks noChangeAspect="1"/>
              </p:cNvPicPr>
              <p:nvPr/>
            </p:nvPicPr>
            <p:blipFill rotWithShape="1">
              <a:blip r:embed="rId2"/>
              <a:srcRect l="-65690" t="4633" r="65690" b="1604"/>
              <a:stretch/>
            </p:blipFill>
            <p:spPr>
              <a:xfrm>
                <a:off x="-3444670" y="1635178"/>
                <a:ext cx="12071509" cy="4676233"/>
              </a:xfrm>
              <a:prstGeom prst="rect">
                <a:avLst/>
              </a:prstGeom>
            </p:spPr>
          </p:pic>
        </p:grpSp>
        <p:pic>
          <p:nvPicPr>
            <p:cNvPr id="8" name="Picture 7"/>
            <p:cNvPicPr>
              <a:picLocks noChangeAspect="1"/>
            </p:cNvPicPr>
            <p:nvPr/>
          </p:nvPicPr>
          <p:blipFill rotWithShape="1">
            <a:blip r:embed="rId3"/>
            <a:srcRect l="47816" t="4196" b="2328"/>
            <a:stretch/>
          </p:blipFill>
          <p:spPr>
            <a:xfrm>
              <a:off x="4700584" y="703484"/>
              <a:ext cx="6299358" cy="4661941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41061603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04800" y="0"/>
            <a:ext cx="18097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MCP (cont.)</a:t>
            </a:r>
            <a:endParaRPr lang="en-US" dirty="0"/>
          </a:p>
        </p:txBody>
      </p:sp>
      <p:sp>
        <p:nvSpPr>
          <p:cNvPr id="6" name="Rectangle 5"/>
          <p:cNvSpPr/>
          <p:nvPr/>
        </p:nvSpPr>
        <p:spPr>
          <a:xfrm>
            <a:off x="1098886" y="3284622"/>
            <a:ext cx="11470105" cy="28073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6" name="Group 15"/>
          <p:cNvGrpSpPr/>
          <p:nvPr/>
        </p:nvGrpSpPr>
        <p:grpSpPr>
          <a:xfrm>
            <a:off x="299803" y="629586"/>
            <a:ext cx="11892197" cy="5249055"/>
            <a:chOff x="299803" y="629586"/>
            <a:chExt cx="11892197" cy="5249055"/>
          </a:xfrm>
        </p:grpSpPr>
        <p:grpSp>
          <p:nvGrpSpPr>
            <p:cNvPr id="13" name="Group 12"/>
            <p:cNvGrpSpPr/>
            <p:nvPr/>
          </p:nvGrpSpPr>
          <p:grpSpPr>
            <a:xfrm>
              <a:off x="781440" y="713907"/>
              <a:ext cx="10575639" cy="5082550"/>
              <a:chOff x="721480" y="354143"/>
              <a:chExt cx="10575639" cy="5082550"/>
            </a:xfrm>
          </p:grpSpPr>
          <p:grpSp>
            <p:nvGrpSpPr>
              <p:cNvPr id="11" name="Group 10"/>
              <p:cNvGrpSpPr/>
              <p:nvPr/>
            </p:nvGrpSpPr>
            <p:grpSpPr>
              <a:xfrm>
                <a:off x="721480" y="354143"/>
                <a:ext cx="2940000" cy="5082550"/>
                <a:chOff x="7347133" y="534025"/>
                <a:chExt cx="2940000" cy="5082550"/>
              </a:xfrm>
            </p:grpSpPr>
            <p:pic>
              <p:nvPicPr>
                <p:cNvPr id="2" name="Picture 1"/>
                <p:cNvPicPr>
                  <a:picLocks noChangeAspect="1"/>
                </p:cNvPicPr>
                <p:nvPr/>
              </p:nvPicPr>
              <p:blipFill rotWithShape="1">
                <a:blip r:embed="rId2"/>
                <a:srcRect l="83204"/>
                <a:stretch/>
              </p:blipFill>
              <p:spPr>
                <a:xfrm>
                  <a:off x="8259581" y="534025"/>
                  <a:ext cx="2027552" cy="4987290"/>
                </a:xfrm>
                <a:prstGeom prst="rect">
                  <a:avLst/>
                </a:prstGeom>
              </p:spPr>
            </p:pic>
            <p:pic>
              <p:nvPicPr>
                <p:cNvPr id="10" name="Picture 9"/>
                <p:cNvPicPr>
                  <a:picLocks noChangeAspect="1"/>
                </p:cNvPicPr>
                <p:nvPr/>
              </p:nvPicPr>
              <p:blipFill rotWithShape="1">
                <a:blip r:embed="rId2"/>
                <a:srcRect l="-1738" t="2104" r="94552" b="-2104"/>
                <a:stretch/>
              </p:blipFill>
              <p:spPr>
                <a:xfrm>
                  <a:off x="7347133" y="629285"/>
                  <a:ext cx="867478" cy="4987290"/>
                </a:xfrm>
                <a:prstGeom prst="rect">
                  <a:avLst/>
                </a:prstGeom>
              </p:spPr>
            </p:pic>
          </p:grpSp>
          <p:pic>
            <p:nvPicPr>
              <p:cNvPr id="12" name="Picture 11"/>
              <p:cNvPicPr>
                <a:picLocks noChangeAspect="1"/>
              </p:cNvPicPr>
              <p:nvPr/>
            </p:nvPicPr>
            <p:blipFill rotWithShape="1">
              <a:blip r:embed="rId3"/>
              <a:srcRect l="4972" r="31946"/>
              <a:stretch/>
            </p:blipFill>
            <p:spPr>
              <a:xfrm>
                <a:off x="3682115" y="354223"/>
                <a:ext cx="7615004" cy="4987290"/>
              </a:xfrm>
              <a:prstGeom prst="rect">
                <a:avLst/>
              </a:prstGeom>
            </p:spPr>
          </p:pic>
        </p:grpSp>
        <p:sp>
          <p:nvSpPr>
            <p:cNvPr id="14" name="Rectangle 13"/>
            <p:cNvSpPr/>
            <p:nvPr/>
          </p:nvSpPr>
          <p:spPr>
            <a:xfrm>
              <a:off x="299803" y="629586"/>
              <a:ext cx="11422505" cy="28481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Rectangle 14"/>
            <p:cNvSpPr/>
            <p:nvPr/>
          </p:nvSpPr>
          <p:spPr>
            <a:xfrm>
              <a:off x="769495" y="5593828"/>
              <a:ext cx="11422505" cy="28481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31217009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84</TotalTime>
  <Words>57</Words>
  <Application>Microsoft Office PowerPoint</Application>
  <PresentationFormat>Widescreen</PresentationFormat>
  <Paragraphs>94</Paragraphs>
  <Slides>1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4</vt:i4>
      </vt:variant>
    </vt:vector>
  </HeadingPairs>
  <TitlesOfParts>
    <vt:vector size="19" baseType="lpstr">
      <vt:lpstr>Arial</vt:lpstr>
      <vt:lpstr>Calibri</vt:lpstr>
      <vt:lpstr>Calibri Light</vt:lpstr>
      <vt:lpstr>Courier New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NCBI-NLM-NIH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utin, Natalya (NIH/NLM/NCBI) [E]</dc:creator>
  <cp:lastModifiedBy>Yutin, Natalya (NIH/NLM/NCBI) [E]</cp:lastModifiedBy>
  <cp:revision>31</cp:revision>
  <dcterms:created xsi:type="dcterms:W3CDTF">2015-05-20T19:16:48Z</dcterms:created>
  <dcterms:modified xsi:type="dcterms:W3CDTF">2015-08-10T05:04:33Z</dcterms:modified>
</cp:coreProperties>
</file>